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154" d="100"/>
          <a:sy n="154" d="100"/>
        </p:scale>
        <p:origin x="534" y="14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7" Type="http://schemas.microsoft.com/office/2016/11/relationships/changesInfo" Target="changesInfos/changesInfo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Joshi, Aniket Sunil" userId="99c22df6-eccd-47fd-9b08-c584eb42b50d" providerId="ADAL" clId="{F697C1D4-0B8E-4413-893B-ADF3DA56559D}"/>
    <pc:docChg chg="addSld modSld">
      <pc:chgData name="Joshi, Aniket Sunil" userId="99c22df6-eccd-47fd-9b08-c584eb42b50d" providerId="ADAL" clId="{F697C1D4-0B8E-4413-893B-ADF3DA56559D}" dt="2025-08-22T20:34:58.894" v="3" actId="1076"/>
      <pc:docMkLst>
        <pc:docMk/>
      </pc:docMkLst>
      <pc:sldChg chg="addSp delSp modSp add">
        <pc:chgData name="Joshi, Aniket Sunil" userId="99c22df6-eccd-47fd-9b08-c584eb42b50d" providerId="ADAL" clId="{F697C1D4-0B8E-4413-893B-ADF3DA56559D}" dt="2025-08-22T20:34:58.894" v="3" actId="1076"/>
        <pc:sldMkLst>
          <pc:docMk/>
          <pc:sldMk cId="2137792168" sldId="256"/>
        </pc:sldMkLst>
        <pc:spChg chg="del">
          <ac:chgData name="Joshi, Aniket Sunil" userId="99c22df6-eccd-47fd-9b08-c584eb42b50d" providerId="ADAL" clId="{F697C1D4-0B8E-4413-893B-ADF3DA56559D}" dt="2025-08-22T20:34:24.033" v="1"/>
          <ac:spMkLst>
            <pc:docMk/>
            <pc:sldMk cId="2137792168" sldId="256"/>
            <ac:spMk id="2" creationId="{71786487-06EA-4F1D-A36C-A93F71352B6A}"/>
          </ac:spMkLst>
        </pc:spChg>
        <pc:spChg chg="del">
          <ac:chgData name="Joshi, Aniket Sunil" userId="99c22df6-eccd-47fd-9b08-c584eb42b50d" providerId="ADAL" clId="{F697C1D4-0B8E-4413-893B-ADF3DA56559D}" dt="2025-08-22T20:34:24.033" v="1"/>
          <ac:spMkLst>
            <pc:docMk/>
            <pc:sldMk cId="2137792168" sldId="256"/>
            <ac:spMk id="3" creationId="{17542D70-D2F2-4D85-8A96-FB5689ED3456}"/>
          </ac:spMkLst>
        </pc:spChg>
        <pc:spChg chg="add mod">
          <ac:chgData name="Joshi, Aniket Sunil" userId="99c22df6-eccd-47fd-9b08-c584eb42b50d" providerId="ADAL" clId="{F697C1D4-0B8E-4413-893B-ADF3DA56559D}" dt="2025-08-22T20:34:58.894" v="3" actId="1076"/>
          <ac:spMkLst>
            <pc:docMk/>
            <pc:sldMk cId="2137792168" sldId="256"/>
            <ac:spMk id="4" creationId="{D047ADF2-012F-443B-8120-3A7C4461EB8E}"/>
          </ac:spMkLst>
        </pc:spChg>
        <pc:spChg chg="add mod">
          <ac:chgData name="Joshi, Aniket Sunil" userId="99c22df6-eccd-47fd-9b08-c584eb42b50d" providerId="ADAL" clId="{F697C1D4-0B8E-4413-893B-ADF3DA56559D}" dt="2025-08-22T20:34:58.894" v="3" actId="1076"/>
          <ac:spMkLst>
            <pc:docMk/>
            <pc:sldMk cId="2137792168" sldId="256"/>
            <ac:spMk id="5" creationId="{C5875951-F3C2-4E27-93FA-EE3EF60404DD}"/>
          </ac:spMkLst>
        </pc:spChg>
        <pc:spChg chg="add mod">
          <ac:chgData name="Joshi, Aniket Sunil" userId="99c22df6-eccd-47fd-9b08-c584eb42b50d" providerId="ADAL" clId="{F697C1D4-0B8E-4413-893B-ADF3DA56559D}" dt="2025-08-22T20:34:58.894" v="3" actId="1076"/>
          <ac:spMkLst>
            <pc:docMk/>
            <pc:sldMk cId="2137792168" sldId="256"/>
            <ac:spMk id="8" creationId="{1DC85057-07F6-4F9B-B13B-0C57BC7B082F}"/>
          </ac:spMkLst>
        </pc:spChg>
        <pc:spChg chg="add mod">
          <ac:chgData name="Joshi, Aniket Sunil" userId="99c22df6-eccd-47fd-9b08-c584eb42b50d" providerId="ADAL" clId="{F697C1D4-0B8E-4413-893B-ADF3DA56559D}" dt="2025-08-22T20:34:58.894" v="3" actId="1076"/>
          <ac:spMkLst>
            <pc:docMk/>
            <pc:sldMk cId="2137792168" sldId="256"/>
            <ac:spMk id="9" creationId="{93A7BCBF-5123-4849-8B5E-7D7DC123F843}"/>
          </ac:spMkLst>
        </pc:spChg>
        <pc:spChg chg="add mod">
          <ac:chgData name="Joshi, Aniket Sunil" userId="99c22df6-eccd-47fd-9b08-c584eb42b50d" providerId="ADAL" clId="{F697C1D4-0B8E-4413-893B-ADF3DA56559D}" dt="2025-08-22T20:34:58.894" v="3" actId="1076"/>
          <ac:spMkLst>
            <pc:docMk/>
            <pc:sldMk cId="2137792168" sldId="256"/>
            <ac:spMk id="12" creationId="{C1A36CC6-B4DD-45F3-8A2F-9B1907137D82}"/>
          </ac:spMkLst>
        </pc:spChg>
        <pc:spChg chg="add mod">
          <ac:chgData name="Joshi, Aniket Sunil" userId="99c22df6-eccd-47fd-9b08-c584eb42b50d" providerId="ADAL" clId="{F697C1D4-0B8E-4413-893B-ADF3DA56559D}" dt="2025-08-22T20:34:58.894" v="3" actId="1076"/>
          <ac:spMkLst>
            <pc:docMk/>
            <pc:sldMk cId="2137792168" sldId="256"/>
            <ac:spMk id="13" creationId="{E1C51DB2-6158-4C83-8845-22D58169FCA7}"/>
          </ac:spMkLst>
        </pc:spChg>
        <pc:spChg chg="add mod">
          <ac:chgData name="Joshi, Aniket Sunil" userId="99c22df6-eccd-47fd-9b08-c584eb42b50d" providerId="ADAL" clId="{F697C1D4-0B8E-4413-893B-ADF3DA56559D}" dt="2025-08-22T20:34:58.894" v="3" actId="1076"/>
          <ac:spMkLst>
            <pc:docMk/>
            <pc:sldMk cId="2137792168" sldId="256"/>
            <ac:spMk id="21" creationId="{782579B4-0173-41DE-B23B-9BC5042BD3BA}"/>
          </ac:spMkLst>
        </pc:spChg>
        <pc:spChg chg="add mod">
          <ac:chgData name="Joshi, Aniket Sunil" userId="99c22df6-eccd-47fd-9b08-c584eb42b50d" providerId="ADAL" clId="{F697C1D4-0B8E-4413-893B-ADF3DA56559D}" dt="2025-08-22T20:34:58.894" v="3" actId="1076"/>
          <ac:spMkLst>
            <pc:docMk/>
            <pc:sldMk cId="2137792168" sldId="256"/>
            <ac:spMk id="22" creationId="{F5258B30-5FEE-401B-87A3-45AE04916F93}"/>
          </ac:spMkLst>
        </pc:spChg>
        <pc:spChg chg="add mod">
          <ac:chgData name="Joshi, Aniket Sunil" userId="99c22df6-eccd-47fd-9b08-c584eb42b50d" providerId="ADAL" clId="{F697C1D4-0B8E-4413-893B-ADF3DA56559D}" dt="2025-08-22T20:34:58.894" v="3" actId="1076"/>
          <ac:spMkLst>
            <pc:docMk/>
            <pc:sldMk cId="2137792168" sldId="256"/>
            <ac:spMk id="23" creationId="{73A9A1EB-C52B-48B1-8820-D37D98E46BD3}"/>
          </ac:spMkLst>
        </pc:spChg>
        <pc:spChg chg="add mod">
          <ac:chgData name="Joshi, Aniket Sunil" userId="99c22df6-eccd-47fd-9b08-c584eb42b50d" providerId="ADAL" clId="{F697C1D4-0B8E-4413-893B-ADF3DA56559D}" dt="2025-08-22T20:34:58.894" v="3" actId="1076"/>
          <ac:spMkLst>
            <pc:docMk/>
            <pc:sldMk cId="2137792168" sldId="256"/>
            <ac:spMk id="24" creationId="{5BC21C06-ABD2-4ABE-8244-38C0F599CDFB}"/>
          </ac:spMkLst>
        </pc:spChg>
        <pc:spChg chg="add mod">
          <ac:chgData name="Joshi, Aniket Sunil" userId="99c22df6-eccd-47fd-9b08-c584eb42b50d" providerId="ADAL" clId="{F697C1D4-0B8E-4413-893B-ADF3DA56559D}" dt="2025-08-22T20:34:58.894" v="3" actId="1076"/>
          <ac:spMkLst>
            <pc:docMk/>
            <pc:sldMk cId="2137792168" sldId="256"/>
            <ac:spMk id="26" creationId="{E20D9761-5D9F-4C9E-BE53-24566106CE26}"/>
          </ac:spMkLst>
        </pc:spChg>
        <pc:spChg chg="add mod">
          <ac:chgData name="Joshi, Aniket Sunil" userId="99c22df6-eccd-47fd-9b08-c584eb42b50d" providerId="ADAL" clId="{F697C1D4-0B8E-4413-893B-ADF3DA56559D}" dt="2025-08-22T20:34:58.894" v="3" actId="1076"/>
          <ac:spMkLst>
            <pc:docMk/>
            <pc:sldMk cId="2137792168" sldId="256"/>
            <ac:spMk id="28" creationId="{08EBC836-1752-4282-9343-2E63B7A0459B}"/>
          </ac:spMkLst>
        </pc:spChg>
        <pc:spChg chg="add mod">
          <ac:chgData name="Joshi, Aniket Sunil" userId="99c22df6-eccd-47fd-9b08-c584eb42b50d" providerId="ADAL" clId="{F697C1D4-0B8E-4413-893B-ADF3DA56559D}" dt="2025-08-22T20:34:58.894" v="3" actId="1076"/>
          <ac:spMkLst>
            <pc:docMk/>
            <pc:sldMk cId="2137792168" sldId="256"/>
            <ac:spMk id="30" creationId="{0BAD5B37-4711-442B-AF46-00CCFB722070}"/>
          </ac:spMkLst>
        </pc:spChg>
        <pc:spChg chg="add mod">
          <ac:chgData name="Joshi, Aniket Sunil" userId="99c22df6-eccd-47fd-9b08-c584eb42b50d" providerId="ADAL" clId="{F697C1D4-0B8E-4413-893B-ADF3DA56559D}" dt="2025-08-22T20:34:58.894" v="3" actId="1076"/>
          <ac:spMkLst>
            <pc:docMk/>
            <pc:sldMk cId="2137792168" sldId="256"/>
            <ac:spMk id="32" creationId="{6F13FD73-DF97-422F-8257-BB5CC0CCF3C4}"/>
          </ac:spMkLst>
        </pc:spChg>
        <pc:spChg chg="add mod">
          <ac:chgData name="Joshi, Aniket Sunil" userId="99c22df6-eccd-47fd-9b08-c584eb42b50d" providerId="ADAL" clId="{F697C1D4-0B8E-4413-893B-ADF3DA56559D}" dt="2025-08-22T20:34:58.894" v="3" actId="1076"/>
          <ac:spMkLst>
            <pc:docMk/>
            <pc:sldMk cId="2137792168" sldId="256"/>
            <ac:spMk id="33" creationId="{21B0F639-6477-4E0A-A322-DE8303E43A14}"/>
          </ac:spMkLst>
        </pc:spChg>
        <pc:spChg chg="add mod">
          <ac:chgData name="Joshi, Aniket Sunil" userId="99c22df6-eccd-47fd-9b08-c584eb42b50d" providerId="ADAL" clId="{F697C1D4-0B8E-4413-893B-ADF3DA56559D}" dt="2025-08-22T20:34:58.894" v="3" actId="1076"/>
          <ac:spMkLst>
            <pc:docMk/>
            <pc:sldMk cId="2137792168" sldId="256"/>
            <ac:spMk id="35" creationId="{08D96B81-57F8-4B59-B524-265FAC5B673D}"/>
          </ac:spMkLst>
        </pc:spChg>
        <pc:spChg chg="add mod">
          <ac:chgData name="Joshi, Aniket Sunil" userId="99c22df6-eccd-47fd-9b08-c584eb42b50d" providerId="ADAL" clId="{F697C1D4-0B8E-4413-893B-ADF3DA56559D}" dt="2025-08-22T20:34:58.894" v="3" actId="1076"/>
          <ac:spMkLst>
            <pc:docMk/>
            <pc:sldMk cId="2137792168" sldId="256"/>
            <ac:spMk id="37" creationId="{31895204-5AAB-4BC4-A2FC-7F318C7EE138}"/>
          </ac:spMkLst>
        </pc:spChg>
        <pc:spChg chg="add mod">
          <ac:chgData name="Joshi, Aniket Sunil" userId="99c22df6-eccd-47fd-9b08-c584eb42b50d" providerId="ADAL" clId="{F697C1D4-0B8E-4413-893B-ADF3DA56559D}" dt="2025-08-22T20:34:58.894" v="3" actId="1076"/>
          <ac:spMkLst>
            <pc:docMk/>
            <pc:sldMk cId="2137792168" sldId="256"/>
            <ac:spMk id="39" creationId="{F2B5EB57-9361-4B04-B1CD-852D1DE6BCE3}"/>
          </ac:spMkLst>
        </pc:spChg>
        <pc:spChg chg="add mod">
          <ac:chgData name="Joshi, Aniket Sunil" userId="99c22df6-eccd-47fd-9b08-c584eb42b50d" providerId="ADAL" clId="{F697C1D4-0B8E-4413-893B-ADF3DA56559D}" dt="2025-08-22T20:34:58.894" v="3" actId="1076"/>
          <ac:spMkLst>
            <pc:docMk/>
            <pc:sldMk cId="2137792168" sldId="256"/>
            <ac:spMk id="41" creationId="{4BD0645E-9277-428F-B7C8-D6C5DB2008B8}"/>
          </ac:spMkLst>
        </pc:spChg>
        <pc:spChg chg="add mod">
          <ac:chgData name="Joshi, Aniket Sunil" userId="99c22df6-eccd-47fd-9b08-c584eb42b50d" providerId="ADAL" clId="{F697C1D4-0B8E-4413-893B-ADF3DA56559D}" dt="2025-08-22T20:34:58.894" v="3" actId="1076"/>
          <ac:spMkLst>
            <pc:docMk/>
            <pc:sldMk cId="2137792168" sldId="256"/>
            <ac:spMk id="42" creationId="{4C7AF465-CFD7-4FBD-B5B0-18F84057B008}"/>
          </ac:spMkLst>
        </pc:spChg>
        <pc:spChg chg="add mod">
          <ac:chgData name="Joshi, Aniket Sunil" userId="99c22df6-eccd-47fd-9b08-c584eb42b50d" providerId="ADAL" clId="{F697C1D4-0B8E-4413-893B-ADF3DA56559D}" dt="2025-08-22T20:34:58.894" v="3" actId="1076"/>
          <ac:spMkLst>
            <pc:docMk/>
            <pc:sldMk cId="2137792168" sldId="256"/>
            <ac:spMk id="44" creationId="{D0DEAFEC-BDE6-4A5A-91F4-5BF0A3BB447A}"/>
          </ac:spMkLst>
        </pc:spChg>
        <pc:spChg chg="add mod">
          <ac:chgData name="Joshi, Aniket Sunil" userId="99c22df6-eccd-47fd-9b08-c584eb42b50d" providerId="ADAL" clId="{F697C1D4-0B8E-4413-893B-ADF3DA56559D}" dt="2025-08-22T20:34:58.894" v="3" actId="1076"/>
          <ac:spMkLst>
            <pc:docMk/>
            <pc:sldMk cId="2137792168" sldId="256"/>
            <ac:spMk id="45" creationId="{974E0AD3-DDF6-4D15-8CA2-EFAD92A92F23}"/>
          </ac:spMkLst>
        </pc:spChg>
        <pc:spChg chg="add mod">
          <ac:chgData name="Joshi, Aniket Sunil" userId="99c22df6-eccd-47fd-9b08-c584eb42b50d" providerId="ADAL" clId="{F697C1D4-0B8E-4413-893B-ADF3DA56559D}" dt="2025-08-22T20:34:58.894" v="3" actId="1076"/>
          <ac:spMkLst>
            <pc:docMk/>
            <pc:sldMk cId="2137792168" sldId="256"/>
            <ac:spMk id="48" creationId="{C5606114-7BE1-4258-86F0-22BF594DF546}"/>
          </ac:spMkLst>
        </pc:spChg>
        <pc:spChg chg="add mod">
          <ac:chgData name="Joshi, Aniket Sunil" userId="99c22df6-eccd-47fd-9b08-c584eb42b50d" providerId="ADAL" clId="{F697C1D4-0B8E-4413-893B-ADF3DA56559D}" dt="2025-08-22T20:34:58.894" v="3" actId="1076"/>
          <ac:spMkLst>
            <pc:docMk/>
            <pc:sldMk cId="2137792168" sldId="256"/>
            <ac:spMk id="49" creationId="{FE669D07-AB1A-43D1-804C-A149BED3C165}"/>
          </ac:spMkLst>
        </pc:spChg>
        <pc:picChg chg="add mod">
          <ac:chgData name="Joshi, Aniket Sunil" userId="99c22df6-eccd-47fd-9b08-c584eb42b50d" providerId="ADAL" clId="{F697C1D4-0B8E-4413-893B-ADF3DA56559D}" dt="2025-08-22T20:34:58.894" v="3" actId="1076"/>
          <ac:picMkLst>
            <pc:docMk/>
            <pc:sldMk cId="2137792168" sldId="256"/>
            <ac:picMk id="16" creationId="{4086356E-D068-454A-B28D-F894F132A2CF}"/>
          </ac:picMkLst>
        </pc:picChg>
        <pc:picChg chg="add mod">
          <ac:chgData name="Joshi, Aniket Sunil" userId="99c22df6-eccd-47fd-9b08-c584eb42b50d" providerId="ADAL" clId="{F697C1D4-0B8E-4413-893B-ADF3DA56559D}" dt="2025-08-22T20:34:58.894" v="3" actId="1076"/>
          <ac:picMkLst>
            <pc:docMk/>
            <pc:sldMk cId="2137792168" sldId="256"/>
            <ac:picMk id="17" creationId="{1B0CE69D-A8BD-421A-BAA1-68ABBF86A196}"/>
          </ac:picMkLst>
        </pc:picChg>
        <pc:picChg chg="add mod">
          <ac:chgData name="Joshi, Aniket Sunil" userId="99c22df6-eccd-47fd-9b08-c584eb42b50d" providerId="ADAL" clId="{F697C1D4-0B8E-4413-893B-ADF3DA56559D}" dt="2025-08-22T20:34:58.894" v="3" actId="1076"/>
          <ac:picMkLst>
            <pc:docMk/>
            <pc:sldMk cId="2137792168" sldId="256"/>
            <ac:picMk id="18" creationId="{6CCB3709-611E-4F55-88BB-EB6D75F3F479}"/>
          </ac:picMkLst>
        </pc:picChg>
        <pc:picChg chg="add mod">
          <ac:chgData name="Joshi, Aniket Sunil" userId="99c22df6-eccd-47fd-9b08-c584eb42b50d" providerId="ADAL" clId="{F697C1D4-0B8E-4413-893B-ADF3DA56559D}" dt="2025-08-22T20:34:58.894" v="3" actId="1076"/>
          <ac:picMkLst>
            <pc:docMk/>
            <pc:sldMk cId="2137792168" sldId="256"/>
            <ac:picMk id="19" creationId="{E1A69EA8-AA0C-4FB5-AAED-B01FE4D53E01}"/>
          </ac:picMkLst>
        </pc:picChg>
        <pc:picChg chg="add mod">
          <ac:chgData name="Joshi, Aniket Sunil" userId="99c22df6-eccd-47fd-9b08-c584eb42b50d" providerId="ADAL" clId="{F697C1D4-0B8E-4413-893B-ADF3DA56559D}" dt="2025-08-22T20:34:58.894" v="3" actId="1076"/>
          <ac:picMkLst>
            <pc:docMk/>
            <pc:sldMk cId="2137792168" sldId="256"/>
            <ac:picMk id="20" creationId="{69DAB555-2129-43F8-9E91-E88DA39CECD3}"/>
          </ac:picMkLst>
        </pc:picChg>
        <pc:picChg chg="add mod">
          <ac:chgData name="Joshi, Aniket Sunil" userId="99c22df6-eccd-47fd-9b08-c584eb42b50d" providerId="ADAL" clId="{F697C1D4-0B8E-4413-893B-ADF3DA56559D}" dt="2025-08-22T20:34:58.894" v="3" actId="1076"/>
          <ac:picMkLst>
            <pc:docMk/>
            <pc:sldMk cId="2137792168" sldId="256"/>
            <ac:picMk id="46" creationId="{67F81FA3-5D46-4062-B66F-25828E97753B}"/>
          </ac:picMkLst>
        </pc:picChg>
        <pc:cxnChg chg="add mod">
          <ac:chgData name="Joshi, Aniket Sunil" userId="99c22df6-eccd-47fd-9b08-c584eb42b50d" providerId="ADAL" clId="{F697C1D4-0B8E-4413-893B-ADF3DA56559D}" dt="2025-08-22T20:34:58.894" v="3" actId="1076"/>
          <ac:cxnSpMkLst>
            <pc:docMk/>
            <pc:sldMk cId="2137792168" sldId="256"/>
            <ac:cxnSpMk id="6" creationId="{847EF4A0-984D-48E2-B53D-8C90D9130460}"/>
          </ac:cxnSpMkLst>
        </pc:cxnChg>
        <pc:cxnChg chg="add mod">
          <ac:chgData name="Joshi, Aniket Sunil" userId="99c22df6-eccd-47fd-9b08-c584eb42b50d" providerId="ADAL" clId="{F697C1D4-0B8E-4413-893B-ADF3DA56559D}" dt="2025-08-22T20:34:58.894" v="3" actId="1076"/>
          <ac:cxnSpMkLst>
            <pc:docMk/>
            <pc:sldMk cId="2137792168" sldId="256"/>
            <ac:cxnSpMk id="7" creationId="{273A3C80-7D4B-4A46-B4C7-8882884BB495}"/>
          </ac:cxnSpMkLst>
        </pc:cxnChg>
        <pc:cxnChg chg="add mod">
          <ac:chgData name="Joshi, Aniket Sunil" userId="99c22df6-eccd-47fd-9b08-c584eb42b50d" providerId="ADAL" clId="{F697C1D4-0B8E-4413-893B-ADF3DA56559D}" dt="2025-08-22T20:34:58.894" v="3" actId="1076"/>
          <ac:cxnSpMkLst>
            <pc:docMk/>
            <pc:sldMk cId="2137792168" sldId="256"/>
            <ac:cxnSpMk id="10" creationId="{2676C913-A79F-451F-9D83-86ABDC100462}"/>
          </ac:cxnSpMkLst>
        </pc:cxnChg>
        <pc:cxnChg chg="add mod">
          <ac:chgData name="Joshi, Aniket Sunil" userId="99c22df6-eccd-47fd-9b08-c584eb42b50d" providerId="ADAL" clId="{F697C1D4-0B8E-4413-893B-ADF3DA56559D}" dt="2025-08-22T20:34:58.894" v="3" actId="1076"/>
          <ac:cxnSpMkLst>
            <pc:docMk/>
            <pc:sldMk cId="2137792168" sldId="256"/>
            <ac:cxnSpMk id="11" creationId="{6EC799EB-126D-49A2-9BC4-AC92A5B87176}"/>
          </ac:cxnSpMkLst>
        </pc:cxnChg>
        <pc:cxnChg chg="add mod">
          <ac:chgData name="Joshi, Aniket Sunil" userId="99c22df6-eccd-47fd-9b08-c584eb42b50d" providerId="ADAL" clId="{F697C1D4-0B8E-4413-893B-ADF3DA56559D}" dt="2025-08-22T20:34:58.894" v="3" actId="1076"/>
          <ac:cxnSpMkLst>
            <pc:docMk/>
            <pc:sldMk cId="2137792168" sldId="256"/>
            <ac:cxnSpMk id="14" creationId="{92C50040-B73E-4467-A9E7-64701D80B798}"/>
          </ac:cxnSpMkLst>
        </pc:cxnChg>
        <pc:cxnChg chg="add mod">
          <ac:chgData name="Joshi, Aniket Sunil" userId="99c22df6-eccd-47fd-9b08-c584eb42b50d" providerId="ADAL" clId="{F697C1D4-0B8E-4413-893B-ADF3DA56559D}" dt="2025-08-22T20:34:58.894" v="3" actId="1076"/>
          <ac:cxnSpMkLst>
            <pc:docMk/>
            <pc:sldMk cId="2137792168" sldId="256"/>
            <ac:cxnSpMk id="15" creationId="{9C894A8B-8518-410F-89F9-DBF567B0D48C}"/>
          </ac:cxnSpMkLst>
        </pc:cxnChg>
        <pc:cxnChg chg="add mod">
          <ac:chgData name="Joshi, Aniket Sunil" userId="99c22df6-eccd-47fd-9b08-c584eb42b50d" providerId="ADAL" clId="{F697C1D4-0B8E-4413-893B-ADF3DA56559D}" dt="2025-08-22T20:34:58.894" v="3" actId="1076"/>
          <ac:cxnSpMkLst>
            <pc:docMk/>
            <pc:sldMk cId="2137792168" sldId="256"/>
            <ac:cxnSpMk id="25" creationId="{D31800D2-F72D-4B0E-9A6C-7378B0B258EE}"/>
          </ac:cxnSpMkLst>
        </pc:cxnChg>
        <pc:cxnChg chg="add mod">
          <ac:chgData name="Joshi, Aniket Sunil" userId="99c22df6-eccd-47fd-9b08-c584eb42b50d" providerId="ADAL" clId="{F697C1D4-0B8E-4413-893B-ADF3DA56559D}" dt="2025-08-22T20:34:58.894" v="3" actId="1076"/>
          <ac:cxnSpMkLst>
            <pc:docMk/>
            <pc:sldMk cId="2137792168" sldId="256"/>
            <ac:cxnSpMk id="27" creationId="{36484501-B688-4536-9625-8BE999CE6566}"/>
          </ac:cxnSpMkLst>
        </pc:cxnChg>
        <pc:cxnChg chg="add mod">
          <ac:chgData name="Joshi, Aniket Sunil" userId="99c22df6-eccd-47fd-9b08-c584eb42b50d" providerId="ADAL" clId="{F697C1D4-0B8E-4413-893B-ADF3DA56559D}" dt="2025-08-22T20:34:58.894" v="3" actId="1076"/>
          <ac:cxnSpMkLst>
            <pc:docMk/>
            <pc:sldMk cId="2137792168" sldId="256"/>
            <ac:cxnSpMk id="29" creationId="{3D378A45-DE4B-4C3D-B5CF-A9D2CE5BF44A}"/>
          </ac:cxnSpMkLst>
        </pc:cxnChg>
        <pc:cxnChg chg="add mod">
          <ac:chgData name="Joshi, Aniket Sunil" userId="99c22df6-eccd-47fd-9b08-c584eb42b50d" providerId="ADAL" clId="{F697C1D4-0B8E-4413-893B-ADF3DA56559D}" dt="2025-08-22T20:34:58.894" v="3" actId="1076"/>
          <ac:cxnSpMkLst>
            <pc:docMk/>
            <pc:sldMk cId="2137792168" sldId="256"/>
            <ac:cxnSpMk id="31" creationId="{0ED70423-6644-47A0-97A8-6DDA65DC8A3A}"/>
          </ac:cxnSpMkLst>
        </pc:cxnChg>
        <pc:cxnChg chg="add mod">
          <ac:chgData name="Joshi, Aniket Sunil" userId="99c22df6-eccd-47fd-9b08-c584eb42b50d" providerId="ADAL" clId="{F697C1D4-0B8E-4413-893B-ADF3DA56559D}" dt="2025-08-22T20:34:58.894" v="3" actId="1076"/>
          <ac:cxnSpMkLst>
            <pc:docMk/>
            <pc:sldMk cId="2137792168" sldId="256"/>
            <ac:cxnSpMk id="34" creationId="{07E628AD-868E-4B6E-A387-49037CFB739D}"/>
          </ac:cxnSpMkLst>
        </pc:cxnChg>
        <pc:cxnChg chg="add mod">
          <ac:chgData name="Joshi, Aniket Sunil" userId="99c22df6-eccd-47fd-9b08-c584eb42b50d" providerId="ADAL" clId="{F697C1D4-0B8E-4413-893B-ADF3DA56559D}" dt="2025-08-22T20:34:58.894" v="3" actId="1076"/>
          <ac:cxnSpMkLst>
            <pc:docMk/>
            <pc:sldMk cId="2137792168" sldId="256"/>
            <ac:cxnSpMk id="36" creationId="{5AB1BF77-F338-42F6-8812-06EBD6A3A3F4}"/>
          </ac:cxnSpMkLst>
        </pc:cxnChg>
        <pc:cxnChg chg="add mod">
          <ac:chgData name="Joshi, Aniket Sunil" userId="99c22df6-eccd-47fd-9b08-c584eb42b50d" providerId="ADAL" clId="{F697C1D4-0B8E-4413-893B-ADF3DA56559D}" dt="2025-08-22T20:34:58.894" v="3" actId="1076"/>
          <ac:cxnSpMkLst>
            <pc:docMk/>
            <pc:sldMk cId="2137792168" sldId="256"/>
            <ac:cxnSpMk id="38" creationId="{BDAB8528-32F7-4C4B-B8A5-7D577CFE9987}"/>
          </ac:cxnSpMkLst>
        </pc:cxnChg>
        <pc:cxnChg chg="add mod">
          <ac:chgData name="Joshi, Aniket Sunil" userId="99c22df6-eccd-47fd-9b08-c584eb42b50d" providerId="ADAL" clId="{F697C1D4-0B8E-4413-893B-ADF3DA56559D}" dt="2025-08-22T20:34:58.894" v="3" actId="1076"/>
          <ac:cxnSpMkLst>
            <pc:docMk/>
            <pc:sldMk cId="2137792168" sldId="256"/>
            <ac:cxnSpMk id="40" creationId="{2768426E-82FE-4901-A6D1-35A8B823DAD0}"/>
          </ac:cxnSpMkLst>
        </pc:cxnChg>
        <pc:cxnChg chg="add mod">
          <ac:chgData name="Joshi, Aniket Sunil" userId="99c22df6-eccd-47fd-9b08-c584eb42b50d" providerId="ADAL" clId="{F697C1D4-0B8E-4413-893B-ADF3DA56559D}" dt="2025-08-22T20:34:58.894" v="3" actId="1076"/>
          <ac:cxnSpMkLst>
            <pc:docMk/>
            <pc:sldMk cId="2137792168" sldId="256"/>
            <ac:cxnSpMk id="43" creationId="{BA5C4953-2247-498B-8513-7523BC5F11EC}"/>
          </ac:cxnSpMkLst>
        </pc:cxnChg>
        <pc:cxnChg chg="add mod">
          <ac:chgData name="Joshi, Aniket Sunil" userId="99c22df6-eccd-47fd-9b08-c584eb42b50d" providerId="ADAL" clId="{F697C1D4-0B8E-4413-893B-ADF3DA56559D}" dt="2025-08-22T20:34:58.894" v="3" actId="1076"/>
          <ac:cxnSpMkLst>
            <pc:docMk/>
            <pc:sldMk cId="2137792168" sldId="256"/>
            <ac:cxnSpMk id="47" creationId="{4215C019-DFA5-4F46-9381-8721CB977ABF}"/>
          </ac:cxnSpMkLst>
        </pc:cxn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30DF6BB-4C65-49E1-BAD8-8E028D5E54CE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FAF5E00F-C969-4D20-ADBC-2111C9F58AF0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3FCB5A2-A07D-4CD0-BFEE-CA8634E8107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8BD0B8-FC81-4517-9257-FD6A0783AE64}" type="datetimeFigureOut">
              <a:rPr lang="en-US" smtClean="0"/>
              <a:t>8/22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BC62D2F-9EA9-4DF0-804A-440D07E4464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2AA035C-9076-4EDC-8FA7-BAD97FFA02B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368184-CD15-4A66-9DF2-BD2BBAAF63F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3555954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3979977-BBEF-4BFF-9E81-D5BAE68E0D3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270FA73A-7339-4E08-B56F-7DFFC72FE93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B085F01-6D74-4D3C-B563-BB519541F15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8BD0B8-FC81-4517-9257-FD6A0783AE64}" type="datetimeFigureOut">
              <a:rPr lang="en-US" smtClean="0"/>
              <a:t>8/22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78A1FA4-0233-4A94-AFE2-402FC2F6A95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1FB2010-E424-4254-8C76-AD6099F9A82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368184-CD15-4A66-9DF2-BD2BBAAF63F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2363848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6176545D-9F4E-4DF2-B799-EC7ABA32700B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B4E9BB09-025B-492F-9F3B-365B99F19CD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C16A801-3329-4323-9F0E-F08ABC4B484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8BD0B8-FC81-4517-9257-FD6A0783AE64}" type="datetimeFigureOut">
              <a:rPr lang="en-US" smtClean="0"/>
              <a:t>8/22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D3B5544-05F7-4ED4-A19B-05F56DCDA96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35C060D-EF32-4B4C-9220-472672802E6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368184-CD15-4A66-9DF2-BD2BBAAF63F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2386423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7464A7D-731E-40AD-A8DE-59DA7F859BE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A79ED65-4929-4E40-ABE5-B2C8CDBDD220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D0A2196-D259-4327-BCF1-C6CFA5684CC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8BD0B8-FC81-4517-9257-FD6A0783AE64}" type="datetimeFigureOut">
              <a:rPr lang="en-US" smtClean="0"/>
              <a:t>8/22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416E280-6DA2-4BAE-A9CE-3D49094CC00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425D734-A76F-4D59-B35D-23007E3EA5F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368184-CD15-4A66-9DF2-BD2BBAAF63F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8495406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D7D00D4-2E39-46AD-AC81-D9C4EC2568B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54FA7E48-FE7A-4D66-A85D-45D6C8D7085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2A27323-D9C5-4D2B-AE4E-2C51A7BFACC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8BD0B8-FC81-4517-9257-FD6A0783AE64}" type="datetimeFigureOut">
              <a:rPr lang="en-US" smtClean="0"/>
              <a:t>8/22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BA10BF0-82EB-4CFE-ACA0-808B394869E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00F3C84-BD1C-478D-8FDC-DAA0C5F29D4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368184-CD15-4A66-9DF2-BD2BBAAF63F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3611922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6FE52F8-10DC-463E-AA26-E54E401405D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3741B2A-753F-4453-81C2-E07FB4401742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FAF4E496-BB26-4182-BCFA-C6F6606C67C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4B5CA588-75E8-442C-89AB-43B94E6590C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8BD0B8-FC81-4517-9257-FD6A0783AE64}" type="datetimeFigureOut">
              <a:rPr lang="en-US" smtClean="0"/>
              <a:t>8/22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6D9ADFFF-CC8D-4D42-8515-6880E202847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7BA171C7-2403-43C4-AA75-A7B5E4CCBF8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368184-CD15-4A66-9DF2-BD2BBAAF63F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8912357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25E635C-1638-4854-9FF7-AADD1CBA593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E74D33B6-EEB8-4915-88E6-A3D2334EF1A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20D21EDA-7652-4352-AF00-81DFDE1A95B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7F041BDD-8521-4B23-9B19-B5DB40995409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B3766266-197F-4D6C-87CB-F858F6AC400F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F37AE982-3434-4887-A67C-753034F5A59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8BD0B8-FC81-4517-9257-FD6A0783AE64}" type="datetimeFigureOut">
              <a:rPr lang="en-US" smtClean="0"/>
              <a:t>8/22/2025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E4C3E42C-6222-4CDD-A0E2-F74ED54D5AF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1AF72BAC-EC5A-4160-AC91-A89C42B97DE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368184-CD15-4A66-9DF2-BD2BBAAF63F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9621873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EAB7B5B-9D77-4970-AF07-02FFC9D7AC6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D39287F4-6943-47BE-A7B5-475D33D96AF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8BD0B8-FC81-4517-9257-FD6A0783AE64}" type="datetimeFigureOut">
              <a:rPr lang="en-US" smtClean="0"/>
              <a:t>8/22/2025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E1F9C3C4-C725-4B67-B16C-24F946CC73A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FF759DAB-855E-4131-ABB9-89CD4977530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368184-CD15-4A66-9DF2-BD2BBAAF63F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4312810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CB6C335A-B923-4FC8-9DF2-236764C02B6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8BD0B8-FC81-4517-9257-FD6A0783AE64}" type="datetimeFigureOut">
              <a:rPr lang="en-US" smtClean="0"/>
              <a:t>8/22/2025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DA26F228-01B8-41EA-9D78-E66F6A19F87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C38DDAC2-33C2-4534-8748-F84575A8FDE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368184-CD15-4A66-9DF2-BD2BBAAF63F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734535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31F1496-00E2-46A4-B4C6-15BCF8DF21F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FB3FE8B-E368-4024-B93F-05744A2BDF65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3D091AE7-8D34-4E48-9B66-EED65EEFE59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813125E6-5AA3-414E-A324-6AFDCA2A9BC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8BD0B8-FC81-4517-9257-FD6A0783AE64}" type="datetimeFigureOut">
              <a:rPr lang="en-US" smtClean="0"/>
              <a:t>8/22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BC3FF66-73E3-40FB-A64E-A6B216C7D9C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4DA67DBC-812A-44A6-A815-FF7403608F7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368184-CD15-4A66-9DF2-BD2BBAAF63F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031411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F479E69-22CF-413F-AACD-D33B735069A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C36EEC62-773D-491D-AFA3-0DB63700FE1E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1D5DFA91-CF45-4FED-B223-478A136B32C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DE898F10-20D5-4251-9C0C-D5618FBBC4F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8BD0B8-FC81-4517-9257-FD6A0783AE64}" type="datetimeFigureOut">
              <a:rPr lang="en-US" smtClean="0"/>
              <a:t>8/22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3BB7450D-A6F0-4EA8-BC99-EA015DFDACB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7F00B186-2E38-43E6-A532-C78B4CC3868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368184-CD15-4A66-9DF2-BD2BBAAF63F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282950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CA228146-FC13-4252-872A-B3E23ED5D59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E7A2809B-663D-498F-B1A5-CC169D0318D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EEE8144-B091-4B5F-963D-5F15B263665C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F8BD0B8-FC81-4517-9257-FD6A0783AE64}" type="datetimeFigureOut">
              <a:rPr lang="en-US" smtClean="0"/>
              <a:t>8/22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1458FE7-1982-4620-B053-F150988C2C83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303CC9B-9F14-4626-9C24-5E02D430AA1B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C368184-CD15-4A66-9DF2-BD2BBAAF63F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9394678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4.png"/><Relationship Id="rId3" Type="http://schemas.microsoft.com/office/2007/relationships/hdphoto" Target="../media/hdphoto1.wdp"/><Relationship Id="rId7" Type="http://schemas.microsoft.com/office/2007/relationships/hdphoto" Target="../media/hdphoto3.wdp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3.png"/><Relationship Id="rId11" Type="http://schemas.microsoft.com/office/2007/relationships/hdphoto" Target="../media/hdphoto4.wdp"/><Relationship Id="rId5" Type="http://schemas.microsoft.com/office/2007/relationships/hdphoto" Target="../media/hdphoto2.wdp"/><Relationship Id="rId10" Type="http://schemas.openxmlformats.org/officeDocument/2006/relationships/image" Target="../media/image6.png"/><Relationship Id="rId4" Type="http://schemas.openxmlformats.org/officeDocument/2006/relationships/image" Target="../media/image2.png"/><Relationship Id="rId9" Type="http://schemas.openxmlformats.org/officeDocument/2006/relationships/image" Target="../media/image5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D047ADF2-012F-443B-8120-3A7C4461EB8E}"/>
              </a:ext>
            </a:extLst>
          </p:cNvPr>
          <p:cNvSpPr txBox="1"/>
          <p:nvPr/>
        </p:nvSpPr>
        <p:spPr>
          <a:xfrm>
            <a:off x="1364153" y="331292"/>
            <a:ext cx="86175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i="1">
                <a:latin typeface="Times New Roman" panose="02020603050405020304" pitchFamily="18" charset="0"/>
                <a:cs typeface="Times New Roman" panose="02020603050405020304" pitchFamily="18" charset="0"/>
              </a:rPr>
              <a:t>Xbp1</a:t>
            </a:r>
            <a:r>
              <a:rPr lang="en-US" sz="1200" b="1" i="1" baseline="30000">
                <a:latin typeface="Times New Roman" panose="02020603050405020304" pitchFamily="18" charset="0"/>
                <a:cs typeface="Times New Roman" panose="02020603050405020304" pitchFamily="18" charset="0"/>
              </a:rPr>
              <a:t>fl/fl</a:t>
            </a:r>
            <a:endParaRPr lang="en-US" sz="12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C5875951-F3C2-4E27-93FA-EE3EF60404DD}"/>
              </a:ext>
            </a:extLst>
          </p:cNvPr>
          <p:cNvSpPr txBox="1"/>
          <p:nvPr/>
        </p:nvSpPr>
        <p:spPr>
          <a:xfrm>
            <a:off x="2643168" y="331292"/>
            <a:ext cx="98161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i="1">
                <a:latin typeface="Times New Roman" panose="02020603050405020304" pitchFamily="18" charset="0"/>
                <a:cs typeface="Times New Roman" panose="02020603050405020304" pitchFamily="18" charset="0"/>
              </a:rPr>
              <a:t>Xbp1</a:t>
            </a:r>
            <a:r>
              <a:rPr lang="en-US" sz="1200" b="1" i="1" baseline="30000">
                <a:latin typeface="Times New Roman" panose="02020603050405020304" pitchFamily="18" charset="0"/>
                <a:cs typeface="Times New Roman" panose="02020603050405020304" pitchFamily="18" charset="0"/>
              </a:rPr>
              <a:t>mKO</a:t>
            </a:r>
            <a:endParaRPr lang="en-US" sz="12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6" name="Straight Connector 5">
            <a:extLst>
              <a:ext uri="{FF2B5EF4-FFF2-40B4-BE49-F238E27FC236}">
                <a16:creationId xmlns:a16="http://schemas.microsoft.com/office/drawing/2014/main" id="{847EF4A0-984D-48E2-B53D-8C90D9130460}"/>
              </a:ext>
            </a:extLst>
          </p:cNvPr>
          <p:cNvCxnSpPr/>
          <p:nvPr/>
        </p:nvCxnSpPr>
        <p:spPr>
          <a:xfrm>
            <a:off x="2495950" y="643077"/>
            <a:ext cx="1386206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" name="Straight Connector 6">
            <a:extLst>
              <a:ext uri="{FF2B5EF4-FFF2-40B4-BE49-F238E27FC236}">
                <a16:creationId xmlns:a16="http://schemas.microsoft.com/office/drawing/2014/main" id="{273A3C80-7D4B-4A46-B4C7-8882884BB495}"/>
              </a:ext>
            </a:extLst>
          </p:cNvPr>
          <p:cNvCxnSpPr/>
          <p:nvPr/>
        </p:nvCxnSpPr>
        <p:spPr>
          <a:xfrm>
            <a:off x="1203214" y="643077"/>
            <a:ext cx="1260187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" name="TextBox 7">
            <a:extLst>
              <a:ext uri="{FF2B5EF4-FFF2-40B4-BE49-F238E27FC236}">
                <a16:creationId xmlns:a16="http://schemas.microsoft.com/office/drawing/2014/main" id="{1DC85057-07F6-4F9B-B13B-0C57BC7B082F}"/>
              </a:ext>
            </a:extLst>
          </p:cNvPr>
          <p:cNvSpPr txBox="1"/>
          <p:nvPr/>
        </p:nvSpPr>
        <p:spPr>
          <a:xfrm>
            <a:off x="1109452" y="601226"/>
            <a:ext cx="63997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>
                <a:latin typeface="Times New Roman" panose="02020603050405020304" pitchFamily="18" charset="0"/>
                <a:cs typeface="Times New Roman" panose="02020603050405020304" pitchFamily="18" charset="0"/>
              </a:rPr>
              <a:t>PBS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93A7BCBF-5123-4849-8B5E-7D7DC123F843}"/>
              </a:ext>
            </a:extLst>
          </p:cNvPr>
          <p:cNvSpPr txBox="1"/>
          <p:nvPr/>
        </p:nvSpPr>
        <p:spPr>
          <a:xfrm>
            <a:off x="1746014" y="601226"/>
            <a:ext cx="68001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>
                <a:latin typeface="Times New Roman" panose="02020603050405020304" pitchFamily="18" charset="0"/>
                <a:cs typeface="Times New Roman" panose="02020603050405020304" pitchFamily="18" charset="0"/>
              </a:rPr>
              <a:t>KPC</a:t>
            </a:r>
          </a:p>
        </p:txBody>
      </p:sp>
      <p:cxnSp>
        <p:nvCxnSpPr>
          <p:cNvPr id="10" name="Straight Connector 9">
            <a:extLst>
              <a:ext uri="{FF2B5EF4-FFF2-40B4-BE49-F238E27FC236}">
                <a16:creationId xmlns:a16="http://schemas.microsoft.com/office/drawing/2014/main" id="{2676C913-A79F-451F-9D83-86ABDC100462}"/>
              </a:ext>
            </a:extLst>
          </p:cNvPr>
          <p:cNvCxnSpPr/>
          <p:nvPr/>
        </p:nvCxnSpPr>
        <p:spPr>
          <a:xfrm>
            <a:off x="1161374" y="851907"/>
            <a:ext cx="534443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" name="Straight Connector 10">
            <a:extLst>
              <a:ext uri="{FF2B5EF4-FFF2-40B4-BE49-F238E27FC236}">
                <a16:creationId xmlns:a16="http://schemas.microsoft.com/office/drawing/2014/main" id="{6EC799EB-126D-49A2-9BC4-AC92A5B87176}"/>
              </a:ext>
            </a:extLst>
          </p:cNvPr>
          <p:cNvCxnSpPr/>
          <p:nvPr/>
        </p:nvCxnSpPr>
        <p:spPr>
          <a:xfrm>
            <a:off x="1730873" y="851907"/>
            <a:ext cx="711343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" name="TextBox 11">
            <a:extLst>
              <a:ext uri="{FF2B5EF4-FFF2-40B4-BE49-F238E27FC236}">
                <a16:creationId xmlns:a16="http://schemas.microsoft.com/office/drawing/2014/main" id="{C1A36CC6-B4DD-45F3-8A2F-9B1907137D82}"/>
              </a:ext>
            </a:extLst>
          </p:cNvPr>
          <p:cNvSpPr txBox="1"/>
          <p:nvPr/>
        </p:nvSpPr>
        <p:spPr>
          <a:xfrm>
            <a:off x="2450577" y="601226"/>
            <a:ext cx="63997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>
                <a:latin typeface="Times New Roman" panose="02020603050405020304" pitchFamily="18" charset="0"/>
                <a:cs typeface="Times New Roman" panose="02020603050405020304" pitchFamily="18" charset="0"/>
              </a:rPr>
              <a:t>PBS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E1C51DB2-6158-4C83-8845-22D58169FCA7}"/>
              </a:ext>
            </a:extLst>
          </p:cNvPr>
          <p:cNvSpPr txBox="1"/>
          <p:nvPr/>
        </p:nvSpPr>
        <p:spPr>
          <a:xfrm>
            <a:off x="3111267" y="601226"/>
            <a:ext cx="68001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>
                <a:latin typeface="Times New Roman" panose="02020603050405020304" pitchFamily="18" charset="0"/>
                <a:cs typeface="Times New Roman" panose="02020603050405020304" pitchFamily="18" charset="0"/>
              </a:rPr>
              <a:t>KPC</a:t>
            </a:r>
          </a:p>
        </p:txBody>
      </p:sp>
      <p:cxnSp>
        <p:nvCxnSpPr>
          <p:cNvPr id="14" name="Straight Connector 13">
            <a:extLst>
              <a:ext uri="{FF2B5EF4-FFF2-40B4-BE49-F238E27FC236}">
                <a16:creationId xmlns:a16="http://schemas.microsoft.com/office/drawing/2014/main" id="{92C50040-B73E-4467-A9E7-64701D80B798}"/>
              </a:ext>
            </a:extLst>
          </p:cNvPr>
          <p:cNvCxnSpPr/>
          <p:nvPr/>
        </p:nvCxnSpPr>
        <p:spPr>
          <a:xfrm>
            <a:off x="2496053" y="851907"/>
            <a:ext cx="534444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" name="Straight Connector 14">
            <a:extLst>
              <a:ext uri="{FF2B5EF4-FFF2-40B4-BE49-F238E27FC236}">
                <a16:creationId xmlns:a16="http://schemas.microsoft.com/office/drawing/2014/main" id="{9C894A8B-8518-410F-89F9-DBF567B0D48C}"/>
              </a:ext>
            </a:extLst>
          </p:cNvPr>
          <p:cNvCxnSpPr>
            <a:cxnSpLocks/>
          </p:cNvCxnSpPr>
          <p:nvPr/>
        </p:nvCxnSpPr>
        <p:spPr>
          <a:xfrm>
            <a:off x="3082018" y="851907"/>
            <a:ext cx="782477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16" name="Picture 15">
            <a:extLst>
              <a:ext uri="{FF2B5EF4-FFF2-40B4-BE49-F238E27FC236}">
                <a16:creationId xmlns:a16="http://schemas.microsoft.com/office/drawing/2014/main" id="{4086356E-D068-454A-B28D-F894F132A2CF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contrast="-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850" t="2555" r="9762" b="27014"/>
          <a:stretch/>
        </p:blipFill>
        <p:spPr>
          <a:xfrm>
            <a:off x="623354" y="3387143"/>
            <a:ext cx="3292251" cy="787990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pic>
        <p:nvPicPr>
          <p:cNvPr id="17" name="Picture 16">
            <a:extLst>
              <a:ext uri="{FF2B5EF4-FFF2-40B4-BE49-F238E27FC236}">
                <a16:creationId xmlns:a16="http://schemas.microsoft.com/office/drawing/2014/main" id="{1B0CE69D-A8BD-421A-BAA1-68ABBF86A196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4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2249" t="17481" r="3987" b="30368"/>
          <a:stretch/>
        </p:blipFill>
        <p:spPr>
          <a:xfrm>
            <a:off x="616433" y="2623076"/>
            <a:ext cx="3429000" cy="675039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pic>
        <p:nvPicPr>
          <p:cNvPr id="18" name="Picture 17">
            <a:extLst>
              <a:ext uri="{FF2B5EF4-FFF2-40B4-BE49-F238E27FC236}">
                <a16:creationId xmlns:a16="http://schemas.microsoft.com/office/drawing/2014/main" id="{6CCB3709-611E-4F55-88BB-EB6D75F3F479}"/>
              </a:ext>
            </a:extLst>
          </p:cNvPr>
          <p:cNvPicPr>
            <a:picLocks noChangeAspect="1"/>
          </p:cNvPicPr>
          <p:nvPr/>
        </p:nvPicPr>
        <p:blipFill rotWithShape="1">
          <a:blip r:embed="rId6"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sharpenSoften amount="-25000"/>
                    </a14:imgEffect>
                    <a14:imgEffect>
                      <a14:saturation sat="0"/>
                    </a14:imgEffect>
                    <a14:imgEffect>
                      <a14:brightnessContrast bright="10000" contrast="60000"/>
                    </a14:imgEffect>
                  </a14:imgLayer>
                </a14:imgProps>
              </a:ext>
            </a:extLst>
          </a:blip>
          <a:srcRect l="21150" t="34542" r="20132" b="48597"/>
          <a:stretch/>
        </p:blipFill>
        <p:spPr>
          <a:xfrm>
            <a:off x="807704" y="5638520"/>
            <a:ext cx="3222381" cy="1069712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pic>
        <p:nvPicPr>
          <p:cNvPr id="19" name="Picture 18">
            <a:extLst>
              <a:ext uri="{FF2B5EF4-FFF2-40B4-BE49-F238E27FC236}">
                <a16:creationId xmlns:a16="http://schemas.microsoft.com/office/drawing/2014/main" id="{E1A69EA8-AA0C-4FB5-AAED-B01FE4D53E01}"/>
              </a:ext>
            </a:extLst>
          </p:cNvPr>
          <p:cNvPicPr>
            <a:picLocks noChangeAspect="1"/>
          </p:cNvPicPr>
          <p:nvPr/>
        </p:nvPicPr>
        <p:blipFill rotWithShape="1"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29" t="2125" r="3296" b="-694"/>
          <a:stretch/>
        </p:blipFill>
        <p:spPr>
          <a:xfrm>
            <a:off x="754873" y="920076"/>
            <a:ext cx="3169604" cy="1659615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pic>
        <p:nvPicPr>
          <p:cNvPr id="20" name="Picture 19">
            <a:extLst>
              <a:ext uri="{FF2B5EF4-FFF2-40B4-BE49-F238E27FC236}">
                <a16:creationId xmlns:a16="http://schemas.microsoft.com/office/drawing/2014/main" id="{69DAB555-2129-43F8-9E91-E88DA39CECD3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333" t="10877" r="3303" b="13390"/>
          <a:stretch/>
        </p:blipFill>
        <p:spPr>
          <a:xfrm>
            <a:off x="747083" y="4254161"/>
            <a:ext cx="3429000" cy="794623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sp>
        <p:nvSpPr>
          <p:cNvPr id="21" name="TextBox 20">
            <a:extLst>
              <a:ext uri="{FF2B5EF4-FFF2-40B4-BE49-F238E27FC236}">
                <a16:creationId xmlns:a16="http://schemas.microsoft.com/office/drawing/2014/main" id="{782579B4-0173-41DE-B23B-9BC5042BD3BA}"/>
              </a:ext>
            </a:extLst>
          </p:cNvPr>
          <p:cNvSpPr txBox="1"/>
          <p:nvPr/>
        </p:nvSpPr>
        <p:spPr>
          <a:xfrm>
            <a:off x="4187991" y="3391262"/>
            <a:ext cx="77830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>
                <a:latin typeface="Times New Roman" panose="02020603050405020304" pitchFamily="18" charset="0"/>
                <a:cs typeface="Times New Roman" panose="02020603050405020304" pitchFamily="18" charset="0"/>
              </a:rPr>
              <a:t>MuRF1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F5258B30-5FEE-401B-87A3-45AE04916F93}"/>
              </a:ext>
            </a:extLst>
          </p:cNvPr>
          <p:cNvSpPr txBox="1"/>
          <p:nvPr/>
        </p:nvSpPr>
        <p:spPr>
          <a:xfrm>
            <a:off x="4187991" y="2805621"/>
            <a:ext cx="77830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>
                <a:latin typeface="Times New Roman" panose="02020603050405020304" pitchFamily="18" charset="0"/>
                <a:cs typeface="Times New Roman" panose="02020603050405020304" pitchFamily="18" charset="0"/>
              </a:rPr>
              <a:t>MAFbx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73A9A1EB-C52B-48B1-8820-D37D98E46BD3}"/>
              </a:ext>
            </a:extLst>
          </p:cNvPr>
          <p:cNvSpPr txBox="1"/>
          <p:nvPr/>
        </p:nvSpPr>
        <p:spPr>
          <a:xfrm>
            <a:off x="4238585" y="5859234"/>
            <a:ext cx="74139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>
                <a:latin typeface="Times New Roman" panose="02020603050405020304" pitchFamily="18" charset="0"/>
                <a:cs typeface="Times New Roman" panose="02020603050405020304" pitchFamily="18" charset="0"/>
              </a:rPr>
              <a:t>Ponceau </a:t>
            </a:r>
          </a:p>
          <a:p>
            <a:r>
              <a:rPr lang="en-US" sz="1200" b="1">
                <a:latin typeface="Times New Roman" panose="02020603050405020304" pitchFamily="18" charset="0"/>
                <a:cs typeface="Times New Roman" panose="02020603050405020304" pitchFamily="18" charset="0"/>
              </a:rPr>
              <a:t>Stain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5BC21C06-ABD2-4ABE-8244-38C0F599CDFB}"/>
              </a:ext>
            </a:extLst>
          </p:cNvPr>
          <p:cNvSpPr txBox="1"/>
          <p:nvPr/>
        </p:nvSpPr>
        <p:spPr>
          <a:xfrm>
            <a:off x="142966" y="508032"/>
            <a:ext cx="89661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>
                <a:latin typeface="Times New Roman" panose="02020603050405020304" pitchFamily="18" charset="0"/>
                <a:cs typeface="Times New Roman" panose="02020603050405020304" pitchFamily="18" charset="0"/>
              </a:rPr>
              <a:t>MW (kDa)</a:t>
            </a:r>
          </a:p>
        </p:txBody>
      </p:sp>
      <p:cxnSp>
        <p:nvCxnSpPr>
          <p:cNvPr id="25" name="Straight Connector 24">
            <a:extLst>
              <a:ext uri="{FF2B5EF4-FFF2-40B4-BE49-F238E27FC236}">
                <a16:creationId xmlns:a16="http://schemas.microsoft.com/office/drawing/2014/main" id="{D31800D2-F72D-4B0E-9A6C-7378B0B258EE}"/>
              </a:ext>
            </a:extLst>
          </p:cNvPr>
          <p:cNvCxnSpPr/>
          <p:nvPr/>
        </p:nvCxnSpPr>
        <p:spPr>
          <a:xfrm>
            <a:off x="605115" y="6142762"/>
            <a:ext cx="336535" cy="0"/>
          </a:xfrm>
          <a:prstGeom prst="line">
            <a:avLst/>
          </a:prstGeom>
          <a:ln w="9525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6" name="TextBox 25">
            <a:extLst>
              <a:ext uri="{FF2B5EF4-FFF2-40B4-BE49-F238E27FC236}">
                <a16:creationId xmlns:a16="http://schemas.microsoft.com/office/drawing/2014/main" id="{E20D9761-5D9F-4C9E-BE53-24566106CE26}"/>
              </a:ext>
            </a:extLst>
          </p:cNvPr>
          <p:cNvSpPr txBox="1"/>
          <p:nvPr/>
        </p:nvSpPr>
        <p:spPr>
          <a:xfrm>
            <a:off x="287715" y="5989088"/>
            <a:ext cx="38154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b="1">
                <a:latin typeface="Times New Roman" panose="02020603050405020304" pitchFamily="18" charset="0"/>
                <a:cs typeface="Times New Roman" panose="02020603050405020304" pitchFamily="18" charset="0"/>
              </a:rPr>
              <a:t>37</a:t>
            </a:r>
          </a:p>
        </p:txBody>
      </p:sp>
      <p:cxnSp>
        <p:nvCxnSpPr>
          <p:cNvPr id="27" name="Straight Connector 26">
            <a:extLst>
              <a:ext uri="{FF2B5EF4-FFF2-40B4-BE49-F238E27FC236}">
                <a16:creationId xmlns:a16="http://schemas.microsoft.com/office/drawing/2014/main" id="{36484501-B688-4536-9625-8BE999CE6566}"/>
              </a:ext>
            </a:extLst>
          </p:cNvPr>
          <p:cNvCxnSpPr/>
          <p:nvPr/>
        </p:nvCxnSpPr>
        <p:spPr>
          <a:xfrm>
            <a:off x="605115" y="5986506"/>
            <a:ext cx="336535" cy="0"/>
          </a:xfrm>
          <a:prstGeom prst="line">
            <a:avLst/>
          </a:prstGeom>
          <a:ln w="9525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8" name="TextBox 27">
            <a:extLst>
              <a:ext uri="{FF2B5EF4-FFF2-40B4-BE49-F238E27FC236}">
                <a16:creationId xmlns:a16="http://schemas.microsoft.com/office/drawing/2014/main" id="{08EBC836-1752-4282-9343-2E63B7A0459B}"/>
              </a:ext>
            </a:extLst>
          </p:cNvPr>
          <p:cNvSpPr txBox="1"/>
          <p:nvPr/>
        </p:nvSpPr>
        <p:spPr>
          <a:xfrm>
            <a:off x="287715" y="5832832"/>
            <a:ext cx="38154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b="1">
                <a:latin typeface="Times New Roman" panose="02020603050405020304" pitchFamily="18" charset="0"/>
                <a:cs typeface="Times New Roman" panose="02020603050405020304" pitchFamily="18" charset="0"/>
              </a:rPr>
              <a:t>50</a:t>
            </a:r>
          </a:p>
        </p:txBody>
      </p:sp>
      <p:cxnSp>
        <p:nvCxnSpPr>
          <p:cNvPr id="29" name="Straight Connector 28">
            <a:extLst>
              <a:ext uri="{FF2B5EF4-FFF2-40B4-BE49-F238E27FC236}">
                <a16:creationId xmlns:a16="http://schemas.microsoft.com/office/drawing/2014/main" id="{3D378A45-DE4B-4C3D-B5CF-A9D2CE5BF44A}"/>
              </a:ext>
            </a:extLst>
          </p:cNvPr>
          <p:cNvCxnSpPr/>
          <p:nvPr/>
        </p:nvCxnSpPr>
        <p:spPr>
          <a:xfrm>
            <a:off x="554521" y="3940230"/>
            <a:ext cx="336535" cy="0"/>
          </a:xfrm>
          <a:prstGeom prst="line">
            <a:avLst/>
          </a:prstGeom>
          <a:ln w="9525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0" name="TextBox 29">
            <a:extLst>
              <a:ext uri="{FF2B5EF4-FFF2-40B4-BE49-F238E27FC236}">
                <a16:creationId xmlns:a16="http://schemas.microsoft.com/office/drawing/2014/main" id="{0BAD5B37-4711-442B-AF46-00CCFB722070}"/>
              </a:ext>
            </a:extLst>
          </p:cNvPr>
          <p:cNvSpPr txBox="1"/>
          <p:nvPr/>
        </p:nvSpPr>
        <p:spPr>
          <a:xfrm>
            <a:off x="237121" y="3786556"/>
            <a:ext cx="38154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b="1">
                <a:latin typeface="Times New Roman" panose="02020603050405020304" pitchFamily="18" charset="0"/>
                <a:cs typeface="Times New Roman" panose="02020603050405020304" pitchFamily="18" charset="0"/>
              </a:rPr>
              <a:t>37</a:t>
            </a:r>
          </a:p>
        </p:txBody>
      </p:sp>
      <p:cxnSp>
        <p:nvCxnSpPr>
          <p:cNvPr id="31" name="Straight Connector 30">
            <a:extLst>
              <a:ext uri="{FF2B5EF4-FFF2-40B4-BE49-F238E27FC236}">
                <a16:creationId xmlns:a16="http://schemas.microsoft.com/office/drawing/2014/main" id="{0ED70423-6644-47A0-97A8-6DDA65DC8A3A}"/>
              </a:ext>
            </a:extLst>
          </p:cNvPr>
          <p:cNvCxnSpPr/>
          <p:nvPr/>
        </p:nvCxnSpPr>
        <p:spPr>
          <a:xfrm>
            <a:off x="553237" y="3175413"/>
            <a:ext cx="336535" cy="0"/>
          </a:xfrm>
          <a:prstGeom prst="line">
            <a:avLst/>
          </a:prstGeom>
          <a:ln w="9525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2" name="TextBox 31">
            <a:extLst>
              <a:ext uri="{FF2B5EF4-FFF2-40B4-BE49-F238E27FC236}">
                <a16:creationId xmlns:a16="http://schemas.microsoft.com/office/drawing/2014/main" id="{6F13FD73-DF97-422F-8257-BB5CC0CCF3C4}"/>
              </a:ext>
            </a:extLst>
          </p:cNvPr>
          <p:cNvSpPr txBox="1"/>
          <p:nvPr/>
        </p:nvSpPr>
        <p:spPr>
          <a:xfrm>
            <a:off x="237121" y="3023015"/>
            <a:ext cx="38154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b="1">
                <a:latin typeface="Times New Roman" panose="02020603050405020304" pitchFamily="18" charset="0"/>
                <a:cs typeface="Times New Roman" panose="02020603050405020304" pitchFamily="18" charset="0"/>
              </a:rPr>
              <a:t>37</a:t>
            </a:r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21B0F639-6477-4E0A-A322-DE8303E43A14}"/>
              </a:ext>
            </a:extLst>
          </p:cNvPr>
          <p:cNvSpPr txBox="1"/>
          <p:nvPr/>
        </p:nvSpPr>
        <p:spPr>
          <a:xfrm>
            <a:off x="3873174" y="1487550"/>
            <a:ext cx="1271492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err="1">
                <a:latin typeface="Times New Roman" panose="02020603050405020304" pitchFamily="18" charset="0"/>
                <a:cs typeface="Times New Roman" panose="02020603050405020304" pitchFamily="18" charset="0"/>
              </a:rPr>
              <a:t>Ub</a:t>
            </a:r>
            <a:r>
              <a:rPr lang="en-US" sz="1200" b="1">
                <a:latin typeface="Times New Roman" panose="02020603050405020304" pitchFamily="18" charset="0"/>
                <a:cs typeface="Times New Roman" panose="02020603050405020304" pitchFamily="18" charset="0"/>
              </a:rPr>
              <a:t>-conjugated proteins</a:t>
            </a:r>
          </a:p>
        </p:txBody>
      </p:sp>
      <p:cxnSp>
        <p:nvCxnSpPr>
          <p:cNvPr id="34" name="Straight Connector 33">
            <a:extLst>
              <a:ext uri="{FF2B5EF4-FFF2-40B4-BE49-F238E27FC236}">
                <a16:creationId xmlns:a16="http://schemas.microsoft.com/office/drawing/2014/main" id="{07E628AD-868E-4B6E-A387-49037CFB739D}"/>
              </a:ext>
            </a:extLst>
          </p:cNvPr>
          <p:cNvCxnSpPr/>
          <p:nvPr/>
        </p:nvCxnSpPr>
        <p:spPr>
          <a:xfrm>
            <a:off x="541175" y="1271144"/>
            <a:ext cx="336535" cy="0"/>
          </a:xfrm>
          <a:prstGeom prst="line">
            <a:avLst/>
          </a:prstGeom>
          <a:ln w="9525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5" name="TextBox 34">
            <a:extLst>
              <a:ext uri="{FF2B5EF4-FFF2-40B4-BE49-F238E27FC236}">
                <a16:creationId xmlns:a16="http://schemas.microsoft.com/office/drawing/2014/main" id="{08D96B81-57F8-4B59-B524-265FAC5B673D}"/>
              </a:ext>
            </a:extLst>
          </p:cNvPr>
          <p:cNvSpPr txBox="1"/>
          <p:nvPr/>
        </p:nvSpPr>
        <p:spPr>
          <a:xfrm>
            <a:off x="148545" y="1117470"/>
            <a:ext cx="45678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b="1">
                <a:latin typeface="Times New Roman" panose="02020603050405020304" pitchFamily="18" charset="0"/>
                <a:cs typeface="Times New Roman" panose="02020603050405020304" pitchFamily="18" charset="0"/>
              </a:rPr>
              <a:t>100</a:t>
            </a:r>
          </a:p>
        </p:txBody>
      </p:sp>
      <p:cxnSp>
        <p:nvCxnSpPr>
          <p:cNvPr id="36" name="Straight Connector 35">
            <a:extLst>
              <a:ext uri="{FF2B5EF4-FFF2-40B4-BE49-F238E27FC236}">
                <a16:creationId xmlns:a16="http://schemas.microsoft.com/office/drawing/2014/main" id="{5AB1BF77-F338-42F6-8812-06EBD6A3A3F4}"/>
              </a:ext>
            </a:extLst>
          </p:cNvPr>
          <p:cNvCxnSpPr/>
          <p:nvPr/>
        </p:nvCxnSpPr>
        <p:spPr>
          <a:xfrm>
            <a:off x="552284" y="1965227"/>
            <a:ext cx="336535" cy="0"/>
          </a:xfrm>
          <a:prstGeom prst="line">
            <a:avLst/>
          </a:prstGeom>
          <a:ln w="9525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7" name="TextBox 36">
            <a:extLst>
              <a:ext uri="{FF2B5EF4-FFF2-40B4-BE49-F238E27FC236}">
                <a16:creationId xmlns:a16="http://schemas.microsoft.com/office/drawing/2014/main" id="{31895204-5AAB-4BC4-A2FC-7F318C7EE138}"/>
              </a:ext>
            </a:extLst>
          </p:cNvPr>
          <p:cNvSpPr txBox="1"/>
          <p:nvPr/>
        </p:nvSpPr>
        <p:spPr>
          <a:xfrm>
            <a:off x="234884" y="1811553"/>
            <a:ext cx="38154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b="1">
                <a:latin typeface="Times New Roman" panose="02020603050405020304" pitchFamily="18" charset="0"/>
                <a:cs typeface="Times New Roman" panose="02020603050405020304" pitchFamily="18" charset="0"/>
              </a:rPr>
              <a:t>37</a:t>
            </a:r>
          </a:p>
        </p:txBody>
      </p:sp>
      <p:cxnSp>
        <p:nvCxnSpPr>
          <p:cNvPr id="38" name="Straight Connector 37">
            <a:extLst>
              <a:ext uri="{FF2B5EF4-FFF2-40B4-BE49-F238E27FC236}">
                <a16:creationId xmlns:a16="http://schemas.microsoft.com/office/drawing/2014/main" id="{BDAB8528-32F7-4C4B-B8A5-7D577CFE9987}"/>
              </a:ext>
            </a:extLst>
          </p:cNvPr>
          <p:cNvCxnSpPr/>
          <p:nvPr/>
        </p:nvCxnSpPr>
        <p:spPr>
          <a:xfrm>
            <a:off x="552284" y="1696576"/>
            <a:ext cx="336535" cy="0"/>
          </a:xfrm>
          <a:prstGeom prst="line">
            <a:avLst/>
          </a:prstGeom>
          <a:ln w="9525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9" name="TextBox 38">
            <a:extLst>
              <a:ext uri="{FF2B5EF4-FFF2-40B4-BE49-F238E27FC236}">
                <a16:creationId xmlns:a16="http://schemas.microsoft.com/office/drawing/2014/main" id="{F2B5EB57-9361-4B04-B1CD-852D1DE6BCE3}"/>
              </a:ext>
            </a:extLst>
          </p:cNvPr>
          <p:cNvSpPr txBox="1"/>
          <p:nvPr/>
        </p:nvSpPr>
        <p:spPr>
          <a:xfrm>
            <a:off x="234884" y="1542902"/>
            <a:ext cx="38154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b="1">
                <a:latin typeface="Times New Roman" panose="02020603050405020304" pitchFamily="18" charset="0"/>
                <a:cs typeface="Times New Roman" panose="02020603050405020304" pitchFamily="18" charset="0"/>
              </a:rPr>
              <a:t>50</a:t>
            </a:r>
          </a:p>
        </p:txBody>
      </p:sp>
      <p:cxnSp>
        <p:nvCxnSpPr>
          <p:cNvPr id="40" name="Straight Connector 39">
            <a:extLst>
              <a:ext uri="{FF2B5EF4-FFF2-40B4-BE49-F238E27FC236}">
                <a16:creationId xmlns:a16="http://schemas.microsoft.com/office/drawing/2014/main" id="{2768426E-82FE-4901-A6D1-35A8B823DAD0}"/>
              </a:ext>
            </a:extLst>
          </p:cNvPr>
          <p:cNvCxnSpPr/>
          <p:nvPr/>
        </p:nvCxnSpPr>
        <p:spPr>
          <a:xfrm>
            <a:off x="552284" y="2309397"/>
            <a:ext cx="336535" cy="0"/>
          </a:xfrm>
          <a:prstGeom prst="line">
            <a:avLst/>
          </a:prstGeom>
          <a:ln w="9525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1" name="TextBox 40">
            <a:extLst>
              <a:ext uri="{FF2B5EF4-FFF2-40B4-BE49-F238E27FC236}">
                <a16:creationId xmlns:a16="http://schemas.microsoft.com/office/drawing/2014/main" id="{4BD0645E-9277-428F-B7C8-D6C5DB2008B8}"/>
              </a:ext>
            </a:extLst>
          </p:cNvPr>
          <p:cNvSpPr txBox="1"/>
          <p:nvPr/>
        </p:nvSpPr>
        <p:spPr>
          <a:xfrm>
            <a:off x="234884" y="2155723"/>
            <a:ext cx="38154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b="1">
                <a:latin typeface="Times New Roman" panose="02020603050405020304" pitchFamily="18" charset="0"/>
                <a:cs typeface="Times New Roman" panose="02020603050405020304" pitchFamily="18" charset="0"/>
              </a:rPr>
              <a:t>25</a:t>
            </a:r>
          </a:p>
        </p:txBody>
      </p:sp>
      <p:sp>
        <p:nvSpPr>
          <p:cNvPr id="42" name="TextBox 41">
            <a:extLst>
              <a:ext uri="{FF2B5EF4-FFF2-40B4-BE49-F238E27FC236}">
                <a16:creationId xmlns:a16="http://schemas.microsoft.com/office/drawing/2014/main" id="{4C7AF465-CFD7-4FBD-B5B0-18F84057B008}"/>
              </a:ext>
            </a:extLst>
          </p:cNvPr>
          <p:cNvSpPr txBox="1"/>
          <p:nvPr/>
        </p:nvSpPr>
        <p:spPr>
          <a:xfrm>
            <a:off x="4238585" y="4470263"/>
            <a:ext cx="846617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>
                <a:latin typeface="Times New Roman" panose="02020603050405020304" pitchFamily="18" charset="0"/>
                <a:cs typeface="Times New Roman" panose="02020603050405020304" pitchFamily="18" charset="0"/>
              </a:rPr>
              <a:t>LC3B-I</a:t>
            </a:r>
          </a:p>
          <a:p>
            <a:r>
              <a:rPr lang="en-US" sz="1200" b="1">
                <a:latin typeface="Times New Roman" panose="02020603050405020304" pitchFamily="18" charset="0"/>
                <a:cs typeface="Times New Roman" panose="02020603050405020304" pitchFamily="18" charset="0"/>
              </a:rPr>
              <a:t>LC3B-II</a:t>
            </a:r>
          </a:p>
        </p:txBody>
      </p:sp>
      <p:cxnSp>
        <p:nvCxnSpPr>
          <p:cNvPr id="43" name="Straight Connector 42">
            <a:extLst>
              <a:ext uri="{FF2B5EF4-FFF2-40B4-BE49-F238E27FC236}">
                <a16:creationId xmlns:a16="http://schemas.microsoft.com/office/drawing/2014/main" id="{BA5C4953-2247-498B-8513-7523BC5F11EC}"/>
              </a:ext>
            </a:extLst>
          </p:cNvPr>
          <p:cNvCxnSpPr/>
          <p:nvPr/>
        </p:nvCxnSpPr>
        <p:spPr>
          <a:xfrm>
            <a:off x="611713" y="4684564"/>
            <a:ext cx="336535" cy="0"/>
          </a:xfrm>
          <a:prstGeom prst="line">
            <a:avLst/>
          </a:prstGeom>
          <a:ln w="9525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4" name="TextBox 43">
            <a:extLst>
              <a:ext uri="{FF2B5EF4-FFF2-40B4-BE49-F238E27FC236}">
                <a16:creationId xmlns:a16="http://schemas.microsoft.com/office/drawing/2014/main" id="{D0DEAFEC-BDE6-4A5A-91F4-5BF0A3BB447A}"/>
              </a:ext>
            </a:extLst>
          </p:cNvPr>
          <p:cNvSpPr txBox="1"/>
          <p:nvPr/>
        </p:nvSpPr>
        <p:spPr>
          <a:xfrm>
            <a:off x="295597" y="4532166"/>
            <a:ext cx="38154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b="1">
                <a:latin typeface="Times New Roman" panose="02020603050405020304" pitchFamily="18" charset="0"/>
                <a:cs typeface="Times New Roman" panose="02020603050405020304" pitchFamily="18" charset="0"/>
              </a:rPr>
              <a:t>15</a:t>
            </a:r>
          </a:p>
        </p:txBody>
      </p:sp>
      <p:sp>
        <p:nvSpPr>
          <p:cNvPr id="45" name="TextBox 44">
            <a:extLst>
              <a:ext uri="{FF2B5EF4-FFF2-40B4-BE49-F238E27FC236}">
                <a16:creationId xmlns:a16="http://schemas.microsoft.com/office/drawing/2014/main" id="{974E0AD3-DDF6-4D15-8CA2-EFAD92A92F23}"/>
              </a:ext>
            </a:extLst>
          </p:cNvPr>
          <p:cNvSpPr txBox="1"/>
          <p:nvPr/>
        </p:nvSpPr>
        <p:spPr>
          <a:xfrm>
            <a:off x="4238585" y="5163698"/>
            <a:ext cx="71414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>
                <a:latin typeface="Times New Roman" panose="02020603050405020304" pitchFamily="18" charset="0"/>
                <a:cs typeface="Times New Roman" panose="02020603050405020304" pitchFamily="18" charset="0"/>
              </a:rPr>
              <a:t>sXBP1</a:t>
            </a:r>
          </a:p>
        </p:txBody>
      </p:sp>
      <p:pic>
        <p:nvPicPr>
          <p:cNvPr id="46" name="Picture 45">
            <a:extLst>
              <a:ext uri="{FF2B5EF4-FFF2-40B4-BE49-F238E27FC236}">
                <a16:creationId xmlns:a16="http://schemas.microsoft.com/office/drawing/2014/main" id="{67F81FA3-5D46-4062-B66F-25828E97753B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10">
            <a:extLst>
              <a:ext uri="{BEBA8EAE-BF5A-486C-A8C5-ECC9F3942E4B}">
                <a14:imgProps xmlns:a14="http://schemas.microsoft.com/office/drawing/2010/main">
                  <a14:imgLayer r:embed="rId11">
                    <a14:imgEffect>
                      <a14:brightnessContrast bright="-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843" t="1480" r="1470" b="13481"/>
          <a:stretch/>
        </p:blipFill>
        <p:spPr>
          <a:xfrm>
            <a:off x="747083" y="5136817"/>
            <a:ext cx="3348944" cy="434292"/>
          </a:xfrm>
          <a:prstGeom prst="rect">
            <a:avLst/>
          </a:prstGeom>
          <a:ln>
            <a:solidFill>
              <a:schemeClr val="tx1"/>
            </a:solidFill>
          </a:ln>
        </p:spPr>
      </p:pic>
      <p:cxnSp>
        <p:nvCxnSpPr>
          <p:cNvPr id="47" name="Straight Connector 46">
            <a:extLst>
              <a:ext uri="{FF2B5EF4-FFF2-40B4-BE49-F238E27FC236}">
                <a16:creationId xmlns:a16="http://schemas.microsoft.com/office/drawing/2014/main" id="{4215C019-DFA5-4F46-9381-8721CB977ABF}"/>
              </a:ext>
            </a:extLst>
          </p:cNvPr>
          <p:cNvCxnSpPr/>
          <p:nvPr/>
        </p:nvCxnSpPr>
        <p:spPr>
          <a:xfrm>
            <a:off x="609799" y="5305906"/>
            <a:ext cx="336535" cy="0"/>
          </a:xfrm>
          <a:prstGeom prst="line">
            <a:avLst/>
          </a:prstGeom>
          <a:ln w="9525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8" name="TextBox 47">
            <a:extLst>
              <a:ext uri="{FF2B5EF4-FFF2-40B4-BE49-F238E27FC236}">
                <a16:creationId xmlns:a16="http://schemas.microsoft.com/office/drawing/2014/main" id="{C5606114-7BE1-4258-86F0-22BF594DF546}"/>
              </a:ext>
            </a:extLst>
          </p:cNvPr>
          <p:cNvSpPr txBox="1"/>
          <p:nvPr/>
        </p:nvSpPr>
        <p:spPr>
          <a:xfrm>
            <a:off x="292399" y="5152232"/>
            <a:ext cx="38154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b="1">
                <a:latin typeface="Times New Roman" panose="02020603050405020304" pitchFamily="18" charset="0"/>
                <a:cs typeface="Times New Roman" panose="02020603050405020304" pitchFamily="18" charset="0"/>
              </a:rPr>
              <a:t>50</a:t>
            </a:r>
          </a:p>
        </p:txBody>
      </p:sp>
      <p:sp>
        <p:nvSpPr>
          <p:cNvPr id="49" name="TextBox 48">
            <a:extLst>
              <a:ext uri="{FF2B5EF4-FFF2-40B4-BE49-F238E27FC236}">
                <a16:creationId xmlns:a16="http://schemas.microsoft.com/office/drawing/2014/main" id="{FE669D07-AB1A-43D1-804C-A149BED3C165}"/>
              </a:ext>
            </a:extLst>
          </p:cNvPr>
          <p:cNvSpPr txBox="1"/>
          <p:nvPr/>
        </p:nvSpPr>
        <p:spPr>
          <a:xfrm>
            <a:off x="261089" y="45871"/>
            <a:ext cx="822661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>
                <a:latin typeface="Times New Roman" panose="02020603050405020304" pitchFamily="18" charset="0"/>
                <a:cs typeface="Times New Roman" panose="02020603050405020304" pitchFamily="18" charset="0"/>
              </a:rPr>
              <a:t>Fig. 4C</a:t>
            </a:r>
          </a:p>
        </p:txBody>
      </p:sp>
    </p:spTree>
    <p:extLst>
      <p:ext uri="{BB962C8B-B14F-4D97-AF65-F5344CB8AC3E}">
        <p14:creationId xmlns:p14="http://schemas.microsoft.com/office/powerpoint/2010/main" val="213779216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34</Words>
  <Application>Microsoft Office PowerPoint</Application>
  <PresentationFormat>Widescreen</PresentationFormat>
  <Paragraphs>26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Joshi, Aniket Sunil</dc:creator>
  <cp:lastModifiedBy>Joshi, Aniket Sunil</cp:lastModifiedBy>
  <cp:revision>2</cp:revision>
  <dcterms:created xsi:type="dcterms:W3CDTF">2025-08-22T20:34:21Z</dcterms:created>
  <dcterms:modified xsi:type="dcterms:W3CDTF">2025-08-22T20:35:08Z</dcterms:modified>
</cp:coreProperties>
</file>